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8280400" cy="5040313"/>
  <p:notesSz cx="6858000" cy="9144000"/>
  <p:defaultTextStyle>
    <a:defPPr>
      <a:defRPr lang="pt-PT"/>
    </a:defPPr>
    <a:lvl1pPr marL="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1pPr>
    <a:lvl2pPr marL="37687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2pPr>
    <a:lvl3pPr marL="75374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3pPr>
    <a:lvl4pPr marL="113061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4pPr>
    <a:lvl5pPr marL="150748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5pPr>
    <a:lvl6pPr marL="188435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6pPr>
    <a:lvl7pPr marL="226122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7pPr>
    <a:lvl8pPr marL="263809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8pPr>
    <a:lvl9pPr marL="3014960" algn="l" defTabSz="753740" rtl="0" eaLnBrk="1" latinLnBrk="0" hangingPunct="1">
      <a:defRPr sz="148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88" userDrawn="1">
          <p15:clr>
            <a:srgbClr val="A4A3A4"/>
          </p15:clr>
        </p15:guide>
        <p15:guide id="2" pos="26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Destaqu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em Estilo, Sem Grelh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96"/>
    <p:restoredTop sz="94684"/>
  </p:normalViewPr>
  <p:slideViewPr>
    <p:cSldViewPr snapToGrid="0" snapToObjects="1" showGuides="1">
      <p:cViewPr varScale="1">
        <p:scale>
          <a:sx n="133" d="100"/>
          <a:sy n="133" d="100"/>
        </p:scale>
        <p:origin x="728" y="184"/>
      </p:cViewPr>
      <p:guideLst>
        <p:guide orient="horz" pos="1588"/>
        <p:guide pos="2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35050" y="824885"/>
            <a:ext cx="6210300" cy="1754776"/>
          </a:xfrm>
        </p:spPr>
        <p:txBody>
          <a:bodyPr anchor="b"/>
          <a:lstStyle>
            <a:lvl1pPr algn="ctr">
              <a:defRPr sz="4075"/>
            </a:lvl1pPr>
          </a:lstStyle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35050" y="2647331"/>
            <a:ext cx="6210300" cy="1216909"/>
          </a:xfrm>
        </p:spPr>
        <p:txBody>
          <a:bodyPr/>
          <a:lstStyle>
            <a:lvl1pPr marL="0" indent="0" algn="ctr">
              <a:buNone/>
              <a:defRPr sz="1630"/>
            </a:lvl1pPr>
            <a:lvl2pPr marL="310530" indent="0" algn="ctr">
              <a:buNone/>
              <a:defRPr sz="1358"/>
            </a:lvl2pPr>
            <a:lvl3pPr marL="621060" indent="0" algn="ctr">
              <a:buNone/>
              <a:defRPr sz="1223"/>
            </a:lvl3pPr>
            <a:lvl4pPr marL="931591" indent="0" algn="ctr">
              <a:buNone/>
              <a:defRPr sz="1087"/>
            </a:lvl4pPr>
            <a:lvl5pPr marL="1242121" indent="0" algn="ctr">
              <a:buNone/>
              <a:defRPr sz="1087"/>
            </a:lvl5pPr>
            <a:lvl6pPr marL="1552651" indent="0" algn="ctr">
              <a:buNone/>
              <a:defRPr sz="1087"/>
            </a:lvl6pPr>
            <a:lvl7pPr marL="1863181" indent="0" algn="ctr">
              <a:buNone/>
              <a:defRPr sz="1087"/>
            </a:lvl7pPr>
            <a:lvl8pPr marL="2173712" indent="0" algn="ctr">
              <a:buNone/>
              <a:defRPr sz="1087"/>
            </a:lvl8pPr>
            <a:lvl9pPr marL="2484242" indent="0" algn="ctr">
              <a:buNone/>
              <a:defRPr sz="1087"/>
            </a:lvl9pPr>
          </a:lstStyle>
          <a:p>
            <a:r>
              <a:rPr lang="pt-PT" smtClean="0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04123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600692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25661" y="268350"/>
            <a:ext cx="1785461" cy="4271432"/>
          </a:xfrm>
        </p:spPr>
        <p:txBody>
          <a:bodyPr vert="eaVert"/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9277" y="268350"/>
            <a:ext cx="5252879" cy="4271432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17399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8373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965" y="1256579"/>
            <a:ext cx="7141845" cy="2096630"/>
          </a:xfrm>
        </p:spPr>
        <p:txBody>
          <a:bodyPr anchor="b"/>
          <a:lstStyle>
            <a:lvl1pPr>
              <a:defRPr sz="4075"/>
            </a:lvl1pPr>
          </a:lstStyle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4965" y="3373044"/>
            <a:ext cx="7141845" cy="1102568"/>
          </a:xfrm>
        </p:spPr>
        <p:txBody>
          <a:bodyPr/>
          <a:lstStyle>
            <a:lvl1pPr marL="0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1pPr>
            <a:lvl2pPr marL="310530" indent="0">
              <a:buNone/>
              <a:defRPr sz="1358">
                <a:solidFill>
                  <a:schemeClr val="tx1">
                    <a:tint val="75000"/>
                  </a:schemeClr>
                </a:solidFill>
              </a:defRPr>
            </a:lvl2pPr>
            <a:lvl3pPr marL="621060" indent="0">
              <a:buNone/>
              <a:defRPr sz="1223">
                <a:solidFill>
                  <a:schemeClr val="tx1">
                    <a:tint val="75000"/>
                  </a:schemeClr>
                </a:solidFill>
              </a:defRPr>
            </a:lvl3pPr>
            <a:lvl4pPr marL="931591" indent="0">
              <a:buNone/>
              <a:defRPr sz="1087">
                <a:solidFill>
                  <a:schemeClr val="tx1">
                    <a:tint val="75000"/>
                  </a:schemeClr>
                </a:solidFill>
              </a:defRPr>
            </a:lvl4pPr>
            <a:lvl5pPr marL="1242121" indent="0">
              <a:buNone/>
              <a:defRPr sz="1087">
                <a:solidFill>
                  <a:schemeClr val="tx1">
                    <a:tint val="75000"/>
                  </a:schemeClr>
                </a:solidFill>
              </a:defRPr>
            </a:lvl5pPr>
            <a:lvl6pPr marL="1552651" indent="0">
              <a:buNone/>
              <a:defRPr sz="1087">
                <a:solidFill>
                  <a:schemeClr val="tx1">
                    <a:tint val="75000"/>
                  </a:schemeClr>
                </a:solidFill>
              </a:defRPr>
            </a:lvl6pPr>
            <a:lvl7pPr marL="1863181" indent="0">
              <a:buNone/>
              <a:defRPr sz="1087">
                <a:solidFill>
                  <a:schemeClr val="tx1">
                    <a:tint val="75000"/>
                  </a:schemeClr>
                </a:solidFill>
              </a:defRPr>
            </a:lvl7pPr>
            <a:lvl8pPr marL="2173712" indent="0">
              <a:buNone/>
              <a:defRPr sz="1087">
                <a:solidFill>
                  <a:schemeClr val="tx1">
                    <a:tint val="75000"/>
                  </a:schemeClr>
                </a:solidFill>
              </a:defRPr>
            </a:lvl8pPr>
            <a:lvl9pPr marL="2484242" indent="0">
              <a:buNone/>
              <a:defRPr sz="108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73664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9278" y="1341750"/>
            <a:ext cx="3519170" cy="3198032"/>
          </a:xfrm>
        </p:spPr>
        <p:txBody>
          <a:bodyPr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1953" y="1341750"/>
            <a:ext cx="3519170" cy="3198032"/>
          </a:xfrm>
        </p:spPr>
        <p:txBody>
          <a:bodyPr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51664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268350"/>
            <a:ext cx="7141845" cy="974228"/>
          </a:xfrm>
        </p:spPr>
        <p:txBody>
          <a:bodyPr/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0356" y="1235577"/>
            <a:ext cx="3502997" cy="605537"/>
          </a:xfrm>
        </p:spPr>
        <p:txBody>
          <a:bodyPr anchor="b"/>
          <a:lstStyle>
            <a:lvl1pPr marL="0" indent="0">
              <a:buNone/>
              <a:defRPr sz="1630" b="1"/>
            </a:lvl1pPr>
            <a:lvl2pPr marL="310530" indent="0">
              <a:buNone/>
              <a:defRPr sz="1358" b="1"/>
            </a:lvl2pPr>
            <a:lvl3pPr marL="621060" indent="0">
              <a:buNone/>
              <a:defRPr sz="1223" b="1"/>
            </a:lvl3pPr>
            <a:lvl4pPr marL="931591" indent="0">
              <a:buNone/>
              <a:defRPr sz="1087" b="1"/>
            </a:lvl4pPr>
            <a:lvl5pPr marL="1242121" indent="0">
              <a:buNone/>
              <a:defRPr sz="1087" b="1"/>
            </a:lvl5pPr>
            <a:lvl6pPr marL="1552651" indent="0">
              <a:buNone/>
              <a:defRPr sz="1087" b="1"/>
            </a:lvl6pPr>
            <a:lvl7pPr marL="1863181" indent="0">
              <a:buNone/>
              <a:defRPr sz="1087" b="1"/>
            </a:lvl7pPr>
            <a:lvl8pPr marL="2173712" indent="0">
              <a:buNone/>
              <a:defRPr sz="1087" b="1"/>
            </a:lvl8pPr>
            <a:lvl9pPr marL="2484242" indent="0">
              <a:buNone/>
              <a:defRPr sz="1087" b="1"/>
            </a:lvl9pPr>
          </a:lstStyle>
          <a:p>
            <a:pPr lvl="0"/>
            <a:r>
              <a:rPr lang="pt-PT" smtClean="0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356" y="1841114"/>
            <a:ext cx="3502997" cy="2708002"/>
          </a:xfrm>
        </p:spPr>
        <p:txBody>
          <a:bodyPr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91952" y="1235577"/>
            <a:ext cx="3520249" cy="605537"/>
          </a:xfrm>
        </p:spPr>
        <p:txBody>
          <a:bodyPr anchor="b"/>
          <a:lstStyle>
            <a:lvl1pPr marL="0" indent="0">
              <a:buNone/>
              <a:defRPr sz="1630" b="1"/>
            </a:lvl1pPr>
            <a:lvl2pPr marL="310530" indent="0">
              <a:buNone/>
              <a:defRPr sz="1358" b="1"/>
            </a:lvl2pPr>
            <a:lvl3pPr marL="621060" indent="0">
              <a:buNone/>
              <a:defRPr sz="1223" b="1"/>
            </a:lvl3pPr>
            <a:lvl4pPr marL="931591" indent="0">
              <a:buNone/>
              <a:defRPr sz="1087" b="1"/>
            </a:lvl4pPr>
            <a:lvl5pPr marL="1242121" indent="0">
              <a:buNone/>
              <a:defRPr sz="1087" b="1"/>
            </a:lvl5pPr>
            <a:lvl6pPr marL="1552651" indent="0">
              <a:buNone/>
              <a:defRPr sz="1087" b="1"/>
            </a:lvl6pPr>
            <a:lvl7pPr marL="1863181" indent="0">
              <a:buNone/>
              <a:defRPr sz="1087" b="1"/>
            </a:lvl7pPr>
            <a:lvl8pPr marL="2173712" indent="0">
              <a:buNone/>
              <a:defRPr sz="1087" b="1"/>
            </a:lvl8pPr>
            <a:lvl9pPr marL="2484242" indent="0">
              <a:buNone/>
              <a:defRPr sz="1087" b="1"/>
            </a:lvl9pPr>
          </a:lstStyle>
          <a:p>
            <a:pPr lvl="0"/>
            <a:r>
              <a:rPr lang="pt-PT" smtClean="0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91952" y="1841114"/>
            <a:ext cx="3520249" cy="2708002"/>
          </a:xfrm>
        </p:spPr>
        <p:txBody>
          <a:bodyPr/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547683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01421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71245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7" y="336021"/>
            <a:ext cx="2670644" cy="1176073"/>
          </a:xfrm>
        </p:spPr>
        <p:txBody>
          <a:bodyPr anchor="b"/>
          <a:lstStyle>
            <a:lvl1pPr>
              <a:defRPr sz="2173"/>
            </a:lvl1pPr>
          </a:lstStyle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0248" y="725712"/>
            <a:ext cx="4191953" cy="3581889"/>
          </a:xfrm>
        </p:spPr>
        <p:txBody>
          <a:bodyPr/>
          <a:lstStyle>
            <a:lvl1pPr>
              <a:defRPr sz="2173"/>
            </a:lvl1pPr>
            <a:lvl2pPr>
              <a:defRPr sz="1902"/>
            </a:lvl2pPr>
            <a:lvl3pPr>
              <a:defRPr sz="1630"/>
            </a:lvl3pPr>
            <a:lvl4pPr>
              <a:defRPr sz="1358"/>
            </a:lvl4pPr>
            <a:lvl5pPr>
              <a:defRPr sz="1358"/>
            </a:lvl5pPr>
            <a:lvl6pPr>
              <a:defRPr sz="1358"/>
            </a:lvl6pPr>
            <a:lvl7pPr>
              <a:defRPr sz="1358"/>
            </a:lvl7pPr>
            <a:lvl8pPr>
              <a:defRPr sz="1358"/>
            </a:lvl8pPr>
            <a:lvl9pPr>
              <a:defRPr sz="1358"/>
            </a:lvl9pPr>
          </a:lstStyle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7" y="1512094"/>
            <a:ext cx="2670644" cy="2801341"/>
          </a:xfrm>
        </p:spPr>
        <p:txBody>
          <a:bodyPr/>
          <a:lstStyle>
            <a:lvl1pPr marL="0" indent="0">
              <a:buNone/>
              <a:defRPr sz="1087"/>
            </a:lvl1pPr>
            <a:lvl2pPr marL="310530" indent="0">
              <a:buNone/>
              <a:defRPr sz="951"/>
            </a:lvl2pPr>
            <a:lvl3pPr marL="621060" indent="0">
              <a:buNone/>
              <a:defRPr sz="815"/>
            </a:lvl3pPr>
            <a:lvl4pPr marL="931591" indent="0">
              <a:buNone/>
              <a:defRPr sz="679"/>
            </a:lvl4pPr>
            <a:lvl5pPr marL="1242121" indent="0">
              <a:buNone/>
              <a:defRPr sz="679"/>
            </a:lvl5pPr>
            <a:lvl6pPr marL="1552651" indent="0">
              <a:buNone/>
              <a:defRPr sz="679"/>
            </a:lvl6pPr>
            <a:lvl7pPr marL="1863181" indent="0">
              <a:buNone/>
              <a:defRPr sz="679"/>
            </a:lvl7pPr>
            <a:lvl8pPr marL="2173712" indent="0">
              <a:buNone/>
              <a:defRPr sz="679"/>
            </a:lvl8pPr>
            <a:lvl9pPr marL="2484242" indent="0">
              <a:buNone/>
              <a:defRPr sz="679"/>
            </a:lvl9pPr>
          </a:lstStyle>
          <a:p>
            <a:pPr lvl="0"/>
            <a:r>
              <a:rPr lang="pt-PT" smtClean="0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09932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7" y="336021"/>
            <a:ext cx="2670644" cy="1176073"/>
          </a:xfrm>
        </p:spPr>
        <p:txBody>
          <a:bodyPr anchor="b"/>
          <a:lstStyle>
            <a:lvl1pPr>
              <a:defRPr sz="2173"/>
            </a:lvl1pPr>
          </a:lstStyle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20248" y="725712"/>
            <a:ext cx="4191953" cy="3581889"/>
          </a:xfrm>
        </p:spPr>
        <p:txBody>
          <a:bodyPr anchor="t"/>
          <a:lstStyle>
            <a:lvl1pPr marL="0" indent="0">
              <a:buNone/>
              <a:defRPr sz="2173"/>
            </a:lvl1pPr>
            <a:lvl2pPr marL="310530" indent="0">
              <a:buNone/>
              <a:defRPr sz="1902"/>
            </a:lvl2pPr>
            <a:lvl3pPr marL="621060" indent="0">
              <a:buNone/>
              <a:defRPr sz="1630"/>
            </a:lvl3pPr>
            <a:lvl4pPr marL="931591" indent="0">
              <a:buNone/>
              <a:defRPr sz="1358"/>
            </a:lvl4pPr>
            <a:lvl5pPr marL="1242121" indent="0">
              <a:buNone/>
              <a:defRPr sz="1358"/>
            </a:lvl5pPr>
            <a:lvl6pPr marL="1552651" indent="0">
              <a:buNone/>
              <a:defRPr sz="1358"/>
            </a:lvl6pPr>
            <a:lvl7pPr marL="1863181" indent="0">
              <a:buNone/>
              <a:defRPr sz="1358"/>
            </a:lvl7pPr>
            <a:lvl8pPr marL="2173712" indent="0">
              <a:buNone/>
              <a:defRPr sz="1358"/>
            </a:lvl8pPr>
            <a:lvl9pPr marL="2484242" indent="0">
              <a:buNone/>
              <a:defRPr sz="1358"/>
            </a:lvl9pPr>
          </a:lstStyle>
          <a:p>
            <a:r>
              <a:rPr lang="pt-PT" smtClean="0"/>
              <a:t>Arraste a imagem até ao marcador de posição ou clique no ícone para adiciona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7" y="1512094"/>
            <a:ext cx="2670644" cy="2801341"/>
          </a:xfrm>
        </p:spPr>
        <p:txBody>
          <a:bodyPr/>
          <a:lstStyle>
            <a:lvl1pPr marL="0" indent="0">
              <a:buNone/>
              <a:defRPr sz="1087"/>
            </a:lvl1pPr>
            <a:lvl2pPr marL="310530" indent="0">
              <a:buNone/>
              <a:defRPr sz="951"/>
            </a:lvl2pPr>
            <a:lvl3pPr marL="621060" indent="0">
              <a:buNone/>
              <a:defRPr sz="815"/>
            </a:lvl3pPr>
            <a:lvl4pPr marL="931591" indent="0">
              <a:buNone/>
              <a:defRPr sz="679"/>
            </a:lvl4pPr>
            <a:lvl5pPr marL="1242121" indent="0">
              <a:buNone/>
              <a:defRPr sz="679"/>
            </a:lvl5pPr>
            <a:lvl6pPr marL="1552651" indent="0">
              <a:buNone/>
              <a:defRPr sz="679"/>
            </a:lvl6pPr>
            <a:lvl7pPr marL="1863181" indent="0">
              <a:buNone/>
              <a:defRPr sz="679"/>
            </a:lvl7pPr>
            <a:lvl8pPr marL="2173712" indent="0">
              <a:buNone/>
              <a:defRPr sz="679"/>
            </a:lvl8pPr>
            <a:lvl9pPr marL="2484242" indent="0">
              <a:buNone/>
              <a:defRPr sz="679"/>
            </a:lvl9pPr>
          </a:lstStyle>
          <a:p>
            <a:pPr lvl="0"/>
            <a:r>
              <a:rPr lang="pt-PT" smtClean="0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90591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9278" y="268350"/>
            <a:ext cx="7141845" cy="974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278" y="1341750"/>
            <a:ext cx="7141845" cy="31980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 do texto de Modelo Global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9278" y="4671624"/>
            <a:ext cx="186309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0281C-23A5-1441-A942-2886EAF9B49C}" type="datetimeFigureOut">
              <a:rPr lang="pt-PT" smtClean="0"/>
              <a:t>09/12/1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42883" y="4671624"/>
            <a:ext cx="2794635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48033" y="4671624"/>
            <a:ext cx="1863090" cy="268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BA4AF1-2F96-E64A-8C5B-7D4CA863BB1C}" type="slidenum">
              <a:rPr lang="pt-PT" smtClean="0"/>
              <a:t>‹n.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05645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21060" rtl="0" eaLnBrk="1" latinLnBrk="0" hangingPunct="1">
        <a:lnSpc>
          <a:spcPct val="90000"/>
        </a:lnSpc>
        <a:spcBef>
          <a:spcPct val="0"/>
        </a:spcBef>
        <a:buNone/>
        <a:defRPr sz="298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265" indent="-155265" algn="l" defTabSz="621060" rtl="0" eaLnBrk="1" latinLnBrk="0" hangingPunct="1">
        <a:lnSpc>
          <a:spcPct val="90000"/>
        </a:lnSpc>
        <a:spcBef>
          <a:spcPts val="679"/>
        </a:spcBef>
        <a:buFont typeface="Arial" panose="020B0604020202020204" pitchFamily="34" charset="0"/>
        <a:buChar char="•"/>
        <a:defRPr sz="1902" kern="1200">
          <a:solidFill>
            <a:schemeClr val="tx1"/>
          </a:solidFill>
          <a:latin typeface="+mn-lt"/>
          <a:ea typeface="+mn-ea"/>
          <a:cs typeface="+mn-cs"/>
        </a:defRPr>
      </a:lvl1pPr>
      <a:lvl2pPr marL="465795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2pPr>
      <a:lvl3pPr marL="776326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358" kern="1200">
          <a:solidFill>
            <a:schemeClr val="tx1"/>
          </a:solidFill>
          <a:latin typeface="+mn-lt"/>
          <a:ea typeface="+mn-ea"/>
          <a:cs typeface="+mn-cs"/>
        </a:defRPr>
      </a:lvl3pPr>
      <a:lvl4pPr marL="1086856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3" kern="1200">
          <a:solidFill>
            <a:schemeClr val="tx1"/>
          </a:solidFill>
          <a:latin typeface="+mn-lt"/>
          <a:ea typeface="+mn-ea"/>
          <a:cs typeface="+mn-cs"/>
        </a:defRPr>
      </a:lvl4pPr>
      <a:lvl5pPr marL="1397386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3" kern="1200">
          <a:solidFill>
            <a:schemeClr val="tx1"/>
          </a:solidFill>
          <a:latin typeface="+mn-lt"/>
          <a:ea typeface="+mn-ea"/>
          <a:cs typeface="+mn-cs"/>
        </a:defRPr>
      </a:lvl5pPr>
      <a:lvl6pPr marL="1707916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3" kern="1200">
          <a:solidFill>
            <a:schemeClr val="tx1"/>
          </a:solidFill>
          <a:latin typeface="+mn-lt"/>
          <a:ea typeface="+mn-ea"/>
          <a:cs typeface="+mn-cs"/>
        </a:defRPr>
      </a:lvl6pPr>
      <a:lvl7pPr marL="2018447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3" kern="1200">
          <a:solidFill>
            <a:schemeClr val="tx1"/>
          </a:solidFill>
          <a:latin typeface="+mn-lt"/>
          <a:ea typeface="+mn-ea"/>
          <a:cs typeface="+mn-cs"/>
        </a:defRPr>
      </a:lvl7pPr>
      <a:lvl8pPr marL="2328977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3" kern="1200">
          <a:solidFill>
            <a:schemeClr val="tx1"/>
          </a:solidFill>
          <a:latin typeface="+mn-lt"/>
          <a:ea typeface="+mn-ea"/>
          <a:cs typeface="+mn-cs"/>
        </a:defRPr>
      </a:lvl8pPr>
      <a:lvl9pPr marL="2639507" indent="-155265" algn="l" defTabSz="621060" rtl="0" eaLnBrk="1" latinLnBrk="0" hangingPunct="1">
        <a:lnSpc>
          <a:spcPct val="90000"/>
        </a:lnSpc>
        <a:spcBef>
          <a:spcPts val="340"/>
        </a:spcBef>
        <a:buFont typeface="Arial" panose="020B0604020202020204" pitchFamily="34" charset="0"/>
        <a:buChar char="•"/>
        <a:defRPr sz="122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1pPr>
      <a:lvl2pPr marL="310530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2pPr>
      <a:lvl3pPr marL="621060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3pPr>
      <a:lvl4pPr marL="931591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4pPr>
      <a:lvl5pPr marL="1242121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5pPr>
      <a:lvl6pPr marL="1552651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6pPr>
      <a:lvl7pPr marL="1863181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7pPr>
      <a:lvl8pPr marL="2173712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8pPr>
      <a:lvl9pPr marL="2484242" algn="l" defTabSz="621060" rtl="0" eaLnBrk="1" latinLnBrk="0" hangingPunct="1">
        <a:defRPr sz="122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2840208"/>
              </p:ext>
            </p:extLst>
          </p:nvPr>
        </p:nvGraphicFramePr>
        <p:xfrm>
          <a:off x="398961" y="3508771"/>
          <a:ext cx="7735970" cy="12192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37984"/>
                <a:gridCol w="1066331"/>
                <a:gridCol w="1066331"/>
                <a:gridCol w="1066331"/>
                <a:gridCol w="1066331"/>
                <a:gridCol w="1066331"/>
                <a:gridCol w="1066331"/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sk-SK" sz="1200" u="none" strike="noStrike" dirty="0">
                          <a:effectLst/>
                        </a:rPr>
                        <a:t> </a:t>
                      </a:r>
                      <a:endParaRPr lang="sk-S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1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2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4a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4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7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 err="1">
                          <a:effectLst/>
                        </a:rPr>
                        <a:t>vegfa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vessels</a:t>
                      </a:r>
                      <a:r>
                        <a:rPr lang="pt-PT" sz="1100" u="none" strike="noStrike" dirty="0">
                          <a:effectLst/>
                        </a:rPr>
                        <a:t> </a:t>
                      </a:r>
                      <a:r>
                        <a:rPr lang="pt-PT" sz="1100" u="none" strike="noStrike" dirty="0" err="1">
                          <a:effectLst/>
                        </a:rPr>
                        <a:t>Ø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bg-BG" sz="1000" u="none" strike="noStrike" dirty="0">
                          <a:effectLst/>
                        </a:rPr>
                        <a:t>0.128 / 0.458</a:t>
                      </a:r>
                      <a:endParaRPr lang="bg-BG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bg-BG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351 / 0.036</a:t>
                      </a:r>
                      <a:endParaRPr lang="bg-BG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 -0.184 / 0.283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000" u="none" strike="noStrike">
                          <a:effectLst/>
                        </a:rPr>
                        <a:t> -0.179 / 0.297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 -0.004 / 0.980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>
                          <a:effectLst/>
                        </a:rPr>
                        <a:t>0.013 / 0.941</a:t>
                      </a:r>
                      <a:endParaRPr lang="sk-SK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>
                          <a:effectLst/>
                        </a:rPr>
                        <a:t>nº </a:t>
                      </a:r>
                      <a:r>
                        <a:rPr lang="pt-PT" sz="1100" u="none" strike="noStrike" dirty="0" err="1">
                          <a:effectLst/>
                        </a:rPr>
                        <a:t>vessel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462 / 0.005</a:t>
                      </a:r>
                      <a:endParaRPr lang="is-IS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0.309 / 0.066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 -0.061 / 0.725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0.112 / 0.517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-0.517 / 0.001</a:t>
                      </a:r>
                      <a:endParaRPr lang="uk-UA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 -0.205 / 0.231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epidermi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 dirty="0">
                          <a:effectLst/>
                        </a:rPr>
                        <a:t> -0.098 / 0.573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0.301 / 0.078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-0.493 / 0.003</a:t>
                      </a:r>
                      <a:endParaRPr lang="pt-BR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0" u="none" strike="noStrike" dirty="0">
                          <a:effectLst/>
                        </a:rPr>
                        <a:t> </a:t>
                      </a:r>
                      <a:r>
                        <a:rPr lang="nb-NO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-0.39 / 0.021</a:t>
                      </a:r>
                      <a:endParaRPr lang="nb-NO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0" u="none" strike="noStrike">
                          <a:effectLst/>
                        </a:rPr>
                        <a:t> -0.315 / 0.065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0" u="none" strike="noStrike">
                          <a:effectLst/>
                        </a:rPr>
                        <a:t>0.078 / 0.658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basement</a:t>
                      </a:r>
                      <a:r>
                        <a:rPr lang="pt-PT" sz="1100" u="none" strike="noStrike" dirty="0">
                          <a:effectLst/>
                        </a:rPr>
                        <a:t> </a:t>
                      </a:r>
                      <a:r>
                        <a:rPr lang="pt-PT" sz="1100" u="none" strike="noStrike" dirty="0" err="1">
                          <a:effectLst/>
                        </a:rPr>
                        <a:t>membrane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>
                          <a:effectLst/>
                        </a:rPr>
                        <a:t> -0.039 / 0.823</a:t>
                      </a:r>
                      <a:endParaRPr lang="uk-UA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0.096 / 0.582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-0.421 / 0.012</a:t>
                      </a:r>
                      <a:endParaRPr lang="pt-BR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 -0.308 / 0.072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 -0.429 / 0.010</a:t>
                      </a:r>
                      <a:endParaRPr lang="pt-BR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0.088 / 0.617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dermi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>
                          <a:effectLst/>
                        </a:rPr>
                        <a:t> -0.198 / 0.247</a:t>
                      </a:r>
                      <a:endParaRPr lang="uk-UA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>
                          <a:effectLst/>
                        </a:rPr>
                        <a:t> -0.036 / 0.834</a:t>
                      </a:r>
                      <a:endParaRPr lang="uk-UA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 -0.002 / 0.9917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 -0.114 / 0.509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0.104 / 0.545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u="none" strike="noStrike" dirty="0">
                          <a:effectLst/>
                        </a:rPr>
                        <a:t>0.199 / 0.245</a:t>
                      </a:r>
                      <a:endParaRPr lang="hr-H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</a:tr>
            </a:tbl>
          </a:graphicData>
        </a:graphic>
      </p:graphicFrame>
      <p:graphicFrame>
        <p:nvGraphicFramePr>
          <p:cNvPr id="5" name="Tabe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2935845"/>
              </p:ext>
            </p:extLst>
          </p:nvPr>
        </p:nvGraphicFramePr>
        <p:xfrm>
          <a:off x="398961" y="1782996"/>
          <a:ext cx="6070599" cy="12192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733809"/>
                <a:gridCol w="1067358"/>
                <a:gridCol w="1067358"/>
                <a:gridCol w="1067358"/>
                <a:gridCol w="1067358"/>
                <a:gridCol w="1067358"/>
              </a:tblGrid>
              <a:tr h="203200">
                <a:tc>
                  <a:txBody>
                    <a:bodyPr/>
                    <a:lstStyle/>
                    <a:p>
                      <a:pPr algn="l" fontAlgn="ctr"/>
                      <a:r>
                        <a:rPr lang="sk-SK" sz="1200" u="none" strike="noStrike" dirty="0">
                          <a:effectLst/>
                        </a:rPr>
                        <a:t> </a:t>
                      </a:r>
                      <a:endParaRPr lang="sk-S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1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2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>
                          <a:effectLst/>
                        </a:rPr>
                        <a:t>angptl4a</a:t>
                      </a:r>
                      <a:endParaRPr lang="pt-PT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>
                          <a:effectLst/>
                        </a:rPr>
                        <a:t>angptl4b</a:t>
                      </a:r>
                      <a:endParaRPr lang="pt-PT" sz="1100" b="1" i="1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i="1" u="none" strike="noStrike" dirty="0">
                          <a:effectLst/>
                        </a:rPr>
                        <a:t>angptl7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i="1" u="none" strike="noStrike" dirty="0" smtClean="0">
                          <a:effectLst/>
                        </a:rPr>
                        <a:t>angptl2b 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559 / 1.22e-7</a:t>
                      </a:r>
                      <a:endParaRPr lang="nb-NO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i="1" u="none" strike="noStrike" dirty="0">
                          <a:effectLst/>
                        </a:rPr>
                        <a:t>angptl4a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0.210 / 0.067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>
                          <a:effectLst/>
                        </a:rPr>
                        <a:t> -0.098 / 0.397</a:t>
                      </a:r>
                      <a:endParaRPr lang="uk-UA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i="1" u="none" strike="noStrike" dirty="0">
                          <a:effectLst/>
                        </a:rPr>
                        <a:t>angptl4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293 / 0.009</a:t>
                      </a:r>
                      <a:endParaRPr lang="hr-HR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1000" u="none" strike="noStrike">
                          <a:effectLst/>
                        </a:rPr>
                        <a:t> -0.079 / 0.493</a:t>
                      </a:r>
                      <a:endParaRPr lang="fi-FI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bg-BG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884 / 0.00</a:t>
                      </a:r>
                      <a:endParaRPr lang="bg-BG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i="1" u="none" strike="noStrike" dirty="0">
                          <a:effectLst/>
                        </a:rPr>
                        <a:t>angptl7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 -0.120 / 0.297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0.028 / 0.811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0.134 / 0.246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0.029 / 0.80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i="1" u="none" strike="noStrike" dirty="0" err="1">
                          <a:effectLst/>
                        </a:rPr>
                        <a:t>vegfab</a:t>
                      </a:r>
                      <a:endParaRPr lang="pt-PT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0" u="none" strike="noStrike">
                          <a:effectLst/>
                        </a:rPr>
                        <a:t> -0.067 / 0.564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0.158 / 0.171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>
                          <a:effectLst/>
                        </a:rPr>
                        <a:t> -0.174 / 0.131</a:t>
                      </a:r>
                      <a:endParaRPr lang="uk-UA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>
                          <a:effectLst/>
                        </a:rPr>
                        <a:t> -0.153 / 0.184</a:t>
                      </a:r>
                      <a:endParaRPr lang="it-IT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 dirty="0">
                          <a:effectLst/>
                        </a:rPr>
                        <a:t>0.184 / 0.108</a:t>
                      </a:r>
                      <a:endParaRPr lang="it-IT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</a:tr>
            </a:tbl>
          </a:graphicData>
        </a:graphic>
      </p:graphicFrame>
      <p:graphicFrame>
        <p:nvGraphicFramePr>
          <p:cNvPr id="6" name="Tabe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1603413"/>
              </p:ext>
            </p:extLst>
          </p:nvPr>
        </p:nvGraphicFramePr>
        <p:xfrm>
          <a:off x="398961" y="260421"/>
          <a:ext cx="5951822" cy="10160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32197"/>
                <a:gridCol w="1066800"/>
                <a:gridCol w="1066800"/>
                <a:gridCol w="1066800"/>
                <a:gridCol w="1419225"/>
              </a:tblGrid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sk-SK" sz="1200" u="none" strike="noStrike" dirty="0">
                          <a:effectLst/>
                        </a:rPr>
                        <a:t> </a:t>
                      </a:r>
                      <a:endParaRPr lang="sk-S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u="none" strike="noStrike" dirty="0" err="1">
                          <a:effectLst/>
                        </a:rPr>
                        <a:t>vessels</a:t>
                      </a:r>
                      <a:r>
                        <a:rPr lang="pt-PT" sz="1100" u="none" strike="noStrike" dirty="0">
                          <a:effectLst/>
                        </a:rPr>
                        <a:t> </a:t>
                      </a:r>
                      <a:r>
                        <a:rPr lang="pt-PT" sz="1100" u="none" strike="noStrike" dirty="0" err="1">
                          <a:effectLst/>
                        </a:rPr>
                        <a:t>Ø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u="none" strike="noStrike" dirty="0">
                          <a:effectLst/>
                        </a:rPr>
                        <a:t>nº </a:t>
                      </a:r>
                      <a:r>
                        <a:rPr lang="pt-PT" sz="1100" u="none" strike="noStrike" dirty="0" err="1">
                          <a:effectLst/>
                        </a:rPr>
                        <a:t>vessel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u="none" strike="noStrike" dirty="0" err="1">
                          <a:effectLst/>
                        </a:rPr>
                        <a:t>epidermi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100" u="none" strike="noStrike" dirty="0" err="1">
                          <a:effectLst/>
                        </a:rPr>
                        <a:t>basement</a:t>
                      </a:r>
                      <a:r>
                        <a:rPr lang="pt-PT" sz="1100" u="none" strike="noStrike" dirty="0">
                          <a:effectLst/>
                        </a:rPr>
                        <a:t> </a:t>
                      </a:r>
                      <a:r>
                        <a:rPr lang="pt-PT" sz="1100" u="none" strike="noStrike" dirty="0" err="1">
                          <a:effectLst/>
                        </a:rPr>
                        <a:t>membrane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>
                          <a:effectLst/>
                        </a:rPr>
                        <a:t>nº </a:t>
                      </a:r>
                      <a:r>
                        <a:rPr lang="pt-PT" sz="1100" u="none" strike="noStrike" dirty="0" err="1">
                          <a:effectLst/>
                        </a:rPr>
                        <a:t>vessel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 dirty="0">
                          <a:effectLst/>
                        </a:rPr>
                        <a:t>0.246 / 0.147</a:t>
                      </a:r>
                      <a:endParaRPr lang="is-I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epidermi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1000" u="none" strike="noStrike">
                          <a:effectLst/>
                        </a:rPr>
                        <a:t>0.237 / 0.169</a:t>
                      </a:r>
                      <a:endParaRPr lang="is-IS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421 / 0.012</a:t>
                      </a:r>
                      <a:endParaRPr lang="it-IT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basement</a:t>
                      </a:r>
                      <a:r>
                        <a:rPr lang="pt-PT" sz="1100" u="none" strike="noStrike" dirty="0">
                          <a:effectLst/>
                        </a:rPr>
                        <a:t> </a:t>
                      </a:r>
                      <a:r>
                        <a:rPr lang="pt-PT" sz="1100" u="none" strike="noStrike" dirty="0" err="1">
                          <a:effectLst/>
                        </a:rPr>
                        <a:t>membrane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>
                          <a:effectLst/>
                        </a:rPr>
                        <a:t> -0.023 / 0.894</a:t>
                      </a:r>
                      <a:endParaRPr lang="pt-BR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385 / 0.023</a:t>
                      </a:r>
                      <a:endParaRPr lang="pt-BR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0.487 / 0.003</a:t>
                      </a:r>
                      <a:endParaRPr lang="pt-BR" sz="1000" b="0" i="0" u="none" strike="noStrike" dirty="0">
                        <a:solidFill>
                          <a:srgbClr val="FF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1000" u="none" strike="noStrike" dirty="0">
                          <a:effectLst/>
                        </a:rPr>
                        <a:t> </a:t>
                      </a:r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solidFill>
                      <a:schemeClr val="bg2"/>
                    </a:solidFill>
                  </a:tcPr>
                </a:tc>
              </a:tr>
              <a:tr h="203200">
                <a:tc>
                  <a:txBody>
                    <a:bodyPr/>
                    <a:lstStyle/>
                    <a:p>
                      <a:pPr algn="r" fontAlgn="ctr"/>
                      <a:r>
                        <a:rPr lang="pt-PT" sz="1100" u="none" strike="noStrike" dirty="0" err="1">
                          <a:effectLst/>
                        </a:rPr>
                        <a:t>dermis</a:t>
                      </a:r>
                      <a:endParaRPr lang="pt-PT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1000" u="none" strike="noStrike">
                          <a:effectLst/>
                        </a:rPr>
                        <a:t> -0.063 / 0.716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 -0.228 / 0.1805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1000" u="none" strike="noStrike" dirty="0">
                          <a:effectLst/>
                        </a:rPr>
                        <a:t>0.092 / 0.601</a:t>
                      </a:r>
                      <a:endParaRPr lang="pt-BR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1000" u="none" strike="noStrike" dirty="0">
                          <a:effectLst/>
                        </a:rPr>
                        <a:t> -0.199 / 0.250</a:t>
                      </a:r>
                      <a:endParaRPr lang="uk-UA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2700" marR="12700" marT="12700" marB="0" anchor="ctr"/>
                </a:tc>
              </a:tr>
            </a:tbl>
          </a:graphicData>
        </a:graphic>
      </p:graphicFrame>
      <p:sp>
        <p:nvSpPr>
          <p:cNvPr id="8" name="CaixaDeTexto 7"/>
          <p:cNvSpPr txBox="1"/>
          <p:nvPr/>
        </p:nvSpPr>
        <p:spPr>
          <a:xfrm>
            <a:off x="53428" y="142779"/>
            <a:ext cx="279244" cy="320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9" name="CaixaDeTexto 8"/>
          <p:cNvSpPr txBox="1"/>
          <p:nvPr/>
        </p:nvSpPr>
        <p:spPr>
          <a:xfrm>
            <a:off x="48619" y="1677023"/>
            <a:ext cx="287258" cy="320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10" name="CaixaDeTexto 9"/>
          <p:cNvSpPr txBox="1"/>
          <p:nvPr/>
        </p:nvSpPr>
        <p:spPr>
          <a:xfrm>
            <a:off x="62245" y="3363894"/>
            <a:ext cx="264816" cy="3207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2789800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261</Words>
  <Application>Microsoft Macintosh PowerPoint</Application>
  <PresentationFormat>Personalizar</PresentationFormat>
  <Paragraphs>106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Rita Costa</dc:creator>
  <cp:lastModifiedBy>Rita Costa</cp:lastModifiedBy>
  <cp:revision>5</cp:revision>
  <dcterms:created xsi:type="dcterms:W3CDTF">2016-09-28T16:07:50Z</dcterms:created>
  <dcterms:modified xsi:type="dcterms:W3CDTF">2016-12-09T13:02:29Z</dcterms:modified>
</cp:coreProperties>
</file>